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9" r:id="rId3"/>
  </p:sldIdLst>
  <p:sldSz cx="12192000" cy="6858000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5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齊藤 卓也" userId="535f7868ac294224" providerId="LiveId" clId="{8C24D787-B4E6-41AB-8BEE-F43A55145545}"/>
    <pc:docChg chg="undo redo custSel delSld modSld">
      <pc:chgData name="齊藤 卓也" userId="535f7868ac294224" providerId="LiveId" clId="{8C24D787-B4E6-41AB-8BEE-F43A55145545}" dt="2021-09-01T21:09:33.222" v="118" actId="20577"/>
      <pc:docMkLst>
        <pc:docMk/>
      </pc:docMkLst>
      <pc:sldChg chg="modSp mod">
        <pc:chgData name="齊藤 卓也" userId="535f7868ac294224" providerId="LiveId" clId="{8C24D787-B4E6-41AB-8BEE-F43A55145545}" dt="2021-09-01T21:06:46.823" v="34" actId="20577"/>
        <pc:sldMkLst>
          <pc:docMk/>
          <pc:sldMk cId="2112906168" sldId="257"/>
        </pc:sldMkLst>
        <pc:spChg chg="mod">
          <ac:chgData name="齊藤 卓也" userId="535f7868ac294224" providerId="LiveId" clId="{8C24D787-B4E6-41AB-8BEE-F43A55145545}" dt="2021-09-01T21:06:46.823" v="34" actId="20577"/>
          <ac:spMkLst>
            <pc:docMk/>
            <pc:sldMk cId="2112906168" sldId="257"/>
            <ac:spMk id="6" creationId="{778F1954-F711-459C-A091-4ED5336D9C14}"/>
          </ac:spMkLst>
        </pc:spChg>
      </pc:sldChg>
      <pc:sldChg chg="modSp mod">
        <pc:chgData name="齊藤 卓也" userId="535f7868ac294224" providerId="LiveId" clId="{8C24D787-B4E6-41AB-8BEE-F43A55145545}" dt="2021-09-01T21:09:33.222" v="118" actId="20577"/>
        <pc:sldMkLst>
          <pc:docMk/>
          <pc:sldMk cId="1853723729" sldId="259"/>
        </pc:sldMkLst>
        <pc:spChg chg="mod">
          <ac:chgData name="齊藤 卓也" userId="535f7868ac294224" providerId="LiveId" clId="{8C24D787-B4E6-41AB-8BEE-F43A55145545}" dt="2021-09-01T21:09:33.222" v="118" actId="20577"/>
          <ac:spMkLst>
            <pc:docMk/>
            <pc:sldMk cId="1853723729" sldId="259"/>
            <ac:spMk id="8" creationId="{6FE24885-D0BF-4AD1-9B1C-4E6C52E0440A}"/>
          </ac:spMkLst>
        </pc:spChg>
        <pc:graphicFrameChg chg="modGraphic">
          <ac:chgData name="齊藤 卓也" userId="535f7868ac294224" providerId="LiveId" clId="{8C24D787-B4E6-41AB-8BEE-F43A55145545}" dt="2021-09-01T21:09:10.291" v="100" actId="20577"/>
          <ac:graphicFrameMkLst>
            <pc:docMk/>
            <pc:sldMk cId="1853723729" sldId="259"/>
            <ac:graphicFrameMk id="9" creationId="{06A72AC9-04F7-4A71-A412-FA36B137DA52}"/>
          </ac:graphicFrameMkLst>
        </pc:graphicFrameChg>
      </pc:sldChg>
      <pc:sldChg chg="del">
        <pc:chgData name="齊藤 卓也" userId="535f7868ac294224" providerId="LiveId" clId="{8C24D787-B4E6-41AB-8BEE-F43A55145545}" dt="2021-08-29T09:44:07.100" v="2" actId="2696"/>
        <pc:sldMkLst>
          <pc:docMk/>
          <pc:sldMk cId="3449391951" sldId="260"/>
        </pc:sldMkLst>
      </pc:sldChg>
      <pc:sldChg chg="del">
        <pc:chgData name="齊藤 卓也" userId="535f7868ac294224" providerId="LiveId" clId="{8C24D787-B4E6-41AB-8BEE-F43A55145545}" dt="2021-08-29T09:44:40.895" v="3" actId="2696"/>
        <pc:sldMkLst>
          <pc:docMk/>
          <pc:sldMk cId="650114600" sldId="261"/>
        </pc:sldMkLst>
      </pc:sldChg>
      <pc:sldChg chg="del">
        <pc:chgData name="齊藤 卓也" userId="535f7868ac294224" providerId="LiveId" clId="{8C24D787-B4E6-41AB-8BEE-F43A55145545}" dt="2021-08-29T09:44:40.895" v="3" actId="2696"/>
        <pc:sldMkLst>
          <pc:docMk/>
          <pc:sldMk cId="1462497610" sldId="262"/>
        </pc:sldMkLst>
      </pc:sldChg>
      <pc:sldChg chg="del">
        <pc:chgData name="齊藤 卓也" userId="535f7868ac294224" providerId="LiveId" clId="{8C24D787-B4E6-41AB-8BEE-F43A55145545}" dt="2021-08-29T09:44:40.895" v="3" actId="2696"/>
        <pc:sldMkLst>
          <pc:docMk/>
          <pc:sldMk cId="1520655707" sldId="263"/>
        </pc:sldMkLst>
      </pc:sldChg>
      <pc:sldChg chg="del">
        <pc:chgData name="齊藤 卓也" userId="535f7868ac294224" providerId="LiveId" clId="{8C24D787-B4E6-41AB-8BEE-F43A55145545}" dt="2021-08-29T09:35:26.523" v="0" actId="2696"/>
        <pc:sldMkLst>
          <pc:docMk/>
          <pc:sldMk cId="1896458787" sldId="627"/>
        </pc:sldMkLst>
      </pc:sldChg>
      <pc:sldChg chg="del">
        <pc:chgData name="齊藤 卓也" userId="535f7868ac294224" providerId="LiveId" clId="{8C24D787-B4E6-41AB-8BEE-F43A55145545}" dt="2021-08-29T09:35:26.523" v="0" actId="2696"/>
        <pc:sldMkLst>
          <pc:docMk/>
          <pc:sldMk cId="1250419399" sldId="628"/>
        </pc:sldMkLst>
      </pc:sldChg>
      <pc:sldChg chg="del">
        <pc:chgData name="齊藤 卓也" userId="535f7868ac294224" providerId="LiveId" clId="{8C24D787-B4E6-41AB-8BEE-F43A55145545}" dt="2021-08-29T09:35:26.523" v="0" actId="2696"/>
        <pc:sldMkLst>
          <pc:docMk/>
          <pc:sldMk cId="2266497160" sldId="629"/>
        </pc:sldMkLst>
      </pc:sldChg>
      <pc:sldChg chg="del">
        <pc:chgData name="齊藤 卓也" userId="535f7868ac294224" providerId="LiveId" clId="{8C24D787-B4E6-41AB-8BEE-F43A55145545}" dt="2021-08-29T09:35:26.523" v="0" actId="2696"/>
        <pc:sldMkLst>
          <pc:docMk/>
          <pc:sldMk cId="2931024107" sldId="630"/>
        </pc:sldMkLst>
      </pc:sldChg>
      <pc:sldMasterChg chg="delSldLayout">
        <pc:chgData name="齊藤 卓也" userId="535f7868ac294224" providerId="LiveId" clId="{8C24D787-B4E6-41AB-8BEE-F43A55145545}" dt="2021-08-29T09:35:26.523" v="0" actId="2696"/>
        <pc:sldMasterMkLst>
          <pc:docMk/>
          <pc:sldMasterMk cId="1941029775" sldId="2147483648"/>
        </pc:sldMasterMkLst>
        <pc:sldLayoutChg chg="del">
          <pc:chgData name="齊藤 卓也" userId="535f7868ac294224" providerId="LiveId" clId="{8C24D787-B4E6-41AB-8BEE-F43A55145545}" dt="2021-08-29T09:35:26.523" v="0" actId="2696"/>
          <pc:sldLayoutMkLst>
            <pc:docMk/>
            <pc:sldMasterMk cId="1941029775" sldId="2147483648"/>
            <pc:sldLayoutMk cId="433947141" sldId="2147483660"/>
          </pc:sldLayoutMkLst>
        </pc:sldLayoutChg>
      </pc:sldMasterChg>
    </pc:docChg>
  </pc:docChgLst>
  <pc:docChgLst>
    <pc:chgData name="齊藤 卓也" userId="535f7868ac294224" providerId="LiveId" clId="{17F6F929-0F21-43E3-AB37-DCCB3CADC9B0}"/>
    <pc:docChg chg="modSld">
      <pc:chgData name="齊藤 卓也" userId="535f7868ac294224" providerId="LiveId" clId="{17F6F929-0F21-43E3-AB37-DCCB3CADC9B0}" dt="2021-08-25T00:02:48.382" v="23" actId="20577"/>
      <pc:docMkLst>
        <pc:docMk/>
      </pc:docMkLst>
      <pc:sldChg chg="modSp mod">
        <pc:chgData name="齊藤 卓也" userId="535f7868ac294224" providerId="LiveId" clId="{17F6F929-0F21-43E3-AB37-DCCB3CADC9B0}" dt="2021-08-25T00:02:48.382" v="23" actId="20577"/>
        <pc:sldMkLst>
          <pc:docMk/>
          <pc:sldMk cId="2112906168" sldId="257"/>
        </pc:sldMkLst>
        <pc:graphicFrameChg chg="modGraphic">
          <ac:chgData name="齊藤 卓也" userId="535f7868ac294224" providerId="LiveId" clId="{17F6F929-0F21-43E3-AB37-DCCB3CADC9B0}" dt="2021-08-25T00:02:48.382" v="23" actId="20577"/>
          <ac:graphicFrameMkLst>
            <pc:docMk/>
            <pc:sldMk cId="2112906168" sldId="257"/>
            <ac:graphicFrameMk id="9" creationId="{5D6CDEE2-A470-4345-BF0B-A48EFABB41E3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1A534-700A-42DF-8DD7-2872B6B237EE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22963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1219"/>
            <a:ext cx="5393690" cy="38873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0D4BB-E64D-4B88-AF72-6BE437A579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875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B38E9A-667B-4973-90E1-C71B771A31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3E3594E-CF7F-436B-ACDB-6FADB59817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630CA9-E4B6-41A6-A329-B417C77BEA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4D2EDC-2E51-4106-B2E5-0CBCE6328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A04381-365A-408D-9FB6-74C32E0E9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7617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9CFF80-425E-471B-AB7E-A63432EDBD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67AD7AB-1DD0-4696-B79F-84C8E4BF2D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C70153-EC6C-45DE-9AA9-3B3475552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575804-FB9C-478D-B760-1944636FA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5CA584-229F-400C-A2AE-343DDB13D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5764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19514AD-8EC7-4B68-A675-97688A6318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00668A1-B74B-40BF-9572-6C7C30B246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55A524-488A-4A59-8547-123E35F5D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0CEDCD-841F-4E42-B5C2-40EFF2862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2D6DFE-5ABB-45C5-9480-BC7759CA8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2855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2EF045-3C63-421E-9B4F-C1F1B6EBA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802D2F0-4420-4EB9-B003-2632729062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C74530-2BBA-427B-9DEB-317F9AC6A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06ACD5-4E4C-403E-B8DF-F6F393D25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84EEC2-5E26-4E1E-8A4E-9B86AD8DF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425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378C46-DAAB-4BAD-B8F9-7D86B7C53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4EA40E5-CF33-4B57-B984-3EA844459B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F1416F-AF8E-4262-8777-27887DEF2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0231E9-6C54-4373-8DFD-1022AABA9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040EA7-AA80-438F-B956-03625E8FE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6731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EBEC19-5602-4375-8E21-409B9E3AF5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A70A6D0-564A-44D5-8D68-A4A44C4C16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E409F0D-994A-4678-ADE5-2F7ADEC06A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B713105-D5FE-4638-8252-828226516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C965FA6-92B1-4EA2-A9A0-F25D15397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C4F66A6-581E-4A01-B3C5-8C2685A93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320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BA7D90-A3A0-4F84-BADC-830CC6EC65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B096C96-E919-4E81-9869-6E57E26434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7ECF7BD-34F0-4E36-BA67-1FB30FF26F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F3123D1-88E6-46AE-9E47-3642C17F4D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6AA0671-0574-4A69-A5D7-63703E3641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668FEC3-E9E1-4198-B486-D2A16239B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75AAB7C-7FEF-4421-9379-44335228B8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95CD5BE-8D6E-4EF7-ACE6-18548B2993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5705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AD9F1C-4961-4552-80E9-F3CF2BD07C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EF03519-0142-4EA8-A3DD-4385FD6D5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6C76E84-1158-4FC6-BC8D-A58F8AA1D3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874AF07-1F20-4076-B1A7-E45E2E27A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383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152337A-210C-45B9-A849-B53AD704C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2545A93-A069-45B3-8CB8-14152AFD3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E9E29BC-3452-43C4-9BFD-087BC430E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8798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E2C610-95D2-4128-84AB-A39EEE16FE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5EAFA7-648E-4DC2-A529-0849F2DF39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278D988-CB95-46D9-AAB7-235B864196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5A492A6-8704-451F-9214-DC91F014E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25E18DC-F36F-459B-BD8C-B61763ED8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4995346-B323-456D-B978-F21BFEB7A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677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218205-E3F0-4394-91F7-FF9D51E61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583BF4B-C5CF-4EA0-8086-A0FBE5AFC4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2F779AB-47FB-4943-B1FD-BC9E00E8FC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EBF1D5-AD55-4B7C-A125-341158B8A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CA648B0-AAF4-48DC-95C7-EEB068B3A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DF0BDA-C387-4885-89AF-8F21383F1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2625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B8F6977-B47E-43E5-8AC0-6E16F8E3F8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79A4106-9220-4440-8B6C-4ABEE84D9C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E4C5DC-B2C7-4D4F-A3EE-8B3DF6BF35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E80D4-4EA1-4767-8E8F-57698B1D6329}" type="datetimeFigureOut">
              <a:rPr kumimoji="1" lang="ja-JP" altLang="en-US" smtClean="0"/>
              <a:t>2021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A5A9B3-C7E7-46FE-ADBE-1FAA9C7693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B1799A-1C54-416E-AEF1-3671A6638F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8F291-583F-4992-8958-7C8D4CE60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1029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5D6CDEE2-A470-4345-BF0B-A48EFABB41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3580876"/>
              </p:ext>
            </p:extLst>
          </p:nvPr>
        </p:nvGraphicFramePr>
        <p:xfrm>
          <a:off x="2571711" y="1042223"/>
          <a:ext cx="6948172" cy="4286863"/>
        </p:xfrm>
        <a:graphic>
          <a:graphicData uri="http://schemas.openxmlformats.org/drawingml/2006/table">
            <a:tbl>
              <a:tblPr/>
              <a:tblGrid>
                <a:gridCol w="209550">
                  <a:extLst>
                    <a:ext uri="{9D8B030D-6E8A-4147-A177-3AD203B41FA5}">
                      <a16:colId xmlns:a16="http://schemas.microsoft.com/office/drawing/2014/main" val="4234914696"/>
                    </a:ext>
                  </a:extLst>
                </a:gridCol>
                <a:gridCol w="1596478">
                  <a:extLst>
                    <a:ext uri="{9D8B030D-6E8A-4147-A177-3AD203B41FA5}">
                      <a16:colId xmlns:a16="http://schemas.microsoft.com/office/drawing/2014/main" val="3636754565"/>
                    </a:ext>
                  </a:extLst>
                </a:gridCol>
                <a:gridCol w="2097698">
                  <a:extLst>
                    <a:ext uri="{9D8B030D-6E8A-4147-A177-3AD203B41FA5}">
                      <a16:colId xmlns:a16="http://schemas.microsoft.com/office/drawing/2014/main" val="2533522208"/>
                    </a:ext>
                  </a:extLst>
                </a:gridCol>
                <a:gridCol w="2320462">
                  <a:extLst>
                    <a:ext uri="{9D8B030D-6E8A-4147-A177-3AD203B41FA5}">
                      <a16:colId xmlns:a16="http://schemas.microsoft.com/office/drawing/2014/main" val="2460059030"/>
                    </a:ext>
                  </a:extLst>
                </a:gridCol>
                <a:gridCol w="723984">
                  <a:extLst>
                    <a:ext uri="{9D8B030D-6E8A-4147-A177-3AD203B41FA5}">
                      <a16:colId xmlns:a16="http://schemas.microsoft.com/office/drawing/2014/main" val="2034054857"/>
                    </a:ext>
                  </a:extLst>
                </a:gridCol>
              </a:tblGrid>
              <a:tr h="313261"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irst half  (R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P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=2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cond half (RIHR=2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4795803"/>
                  </a:ext>
                </a:extLst>
              </a:tr>
              <a:tr h="301213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atient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3521037"/>
                  </a:ext>
                </a:extLst>
              </a:tr>
              <a:tr h="301213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ge (year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8 (56 - 7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0 (61 - 7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29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5201628"/>
                  </a:ext>
                </a:extLst>
              </a:tr>
              <a:tr h="301213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x (male/female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/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/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48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290953"/>
                  </a:ext>
                </a:extLst>
              </a:tr>
              <a:tr h="301213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MI (kg/m</a:t>
                      </a:r>
                      <a:r>
                        <a:rPr lang="en-US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8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6553208"/>
                  </a:ext>
                </a:extLst>
              </a:tr>
              <a:tr h="474712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ilateral inguinal herni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 (33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 (2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5870862"/>
                  </a:ext>
                </a:extLst>
              </a:tr>
              <a:tr h="474712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nilateral inguinal herni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 (67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 (7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7165219"/>
                  </a:ext>
                </a:extLst>
              </a:tr>
              <a:tr h="301213"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eft sid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 (2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 (42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8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9141001"/>
                  </a:ext>
                </a:extLst>
              </a:tr>
              <a:tr h="301213"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ight sid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 (8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 (58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3293847"/>
                  </a:ext>
                </a:extLst>
              </a:tr>
              <a:tr h="30121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rnia typ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8278697"/>
                  </a:ext>
                </a:extLst>
              </a:tr>
              <a:tr h="301213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ire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 (40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 (2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6773226"/>
                  </a:ext>
                </a:extLst>
              </a:tr>
              <a:tr h="301213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ndire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 (5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 (7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8481197"/>
                  </a:ext>
                </a:extLst>
              </a:tr>
              <a:tr h="3132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Othe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 (5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4122713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F653361-54FF-4E68-BAE7-2F132E434852}"/>
              </a:ext>
            </a:extLst>
          </p:cNvPr>
          <p:cNvSpPr txBox="1"/>
          <p:nvPr/>
        </p:nvSpPr>
        <p:spPr>
          <a:xfrm>
            <a:off x="2571709" y="5446447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76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xpressed as N (%) or median (range)</a:t>
            </a:r>
            <a:r>
              <a:rPr kumimoji="0"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ja-JP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78F1954-F711-459C-A091-4ED5336D9C14}"/>
              </a:ext>
            </a:extLst>
          </p:cNvPr>
          <p:cNvSpPr txBox="1"/>
          <p:nvPr/>
        </p:nvSpPr>
        <p:spPr>
          <a:xfrm>
            <a:off x="1455175" y="543943"/>
            <a:ext cx="59872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table 1</a:t>
            </a:r>
            <a:endParaRPr kumimoji="0"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29061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FE24885-D0BF-4AD1-9B1C-4E6C52E0440A}"/>
              </a:ext>
            </a:extLst>
          </p:cNvPr>
          <p:cNvSpPr txBox="1"/>
          <p:nvPr/>
        </p:nvSpPr>
        <p:spPr>
          <a:xfrm>
            <a:off x="1445343" y="533089"/>
            <a:ext cx="47328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table 2</a:t>
            </a:r>
            <a:endParaRPr kumimoji="0"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06A72AC9-04F7-4A71-A412-FA36B137DA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8483958"/>
              </p:ext>
            </p:extLst>
          </p:nvPr>
        </p:nvGraphicFramePr>
        <p:xfrm>
          <a:off x="2192594" y="1081552"/>
          <a:ext cx="7934632" cy="4444181"/>
        </p:xfrm>
        <a:graphic>
          <a:graphicData uri="http://schemas.openxmlformats.org/drawingml/2006/table">
            <a:tbl>
              <a:tblPr/>
              <a:tblGrid>
                <a:gridCol w="475264">
                  <a:extLst>
                    <a:ext uri="{9D8B030D-6E8A-4147-A177-3AD203B41FA5}">
                      <a16:colId xmlns:a16="http://schemas.microsoft.com/office/drawing/2014/main" val="426900054"/>
                    </a:ext>
                  </a:extLst>
                </a:gridCol>
                <a:gridCol w="2498527">
                  <a:extLst>
                    <a:ext uri="{9D8B030D-6E8A-4147-A177-3AD203B41FA5}">
                      <a16:colId xmlns:a16="http://schemas.microsoft.com/office/drawing/2014/main" val="3146000350"/>
                    </a:ext>
                  </a:extLst>
                </a:gridCol>
                <a:gridCol w="2045894">
                  <a:extLst>
                    <a:ext uri="{9D8B030D-6E8A-4147-A177-3AD203B41FA5}">
                      <a16:colId xmlns:a16="http://schemas.microsoft.com/office/drawing/2014/main" val="1439345372"/>
                    </a:ext>
                  </a:extLst>
                </a:gridCol>
                <a:gridCol w="2263158">
                  <a:extLst>
                    <a:ext uri="{9D8B030D-6E8A-4147-A177-3AD203B41FA5}">
                      <a16:colId xmlns:a16="http://schemas.microsoft.com/office/drawing/2014/main" val="379402910"/>
                    </a:ext>
                  </a:extLst>
                </a:gridCol>
                <a:gridCol w="651789">
                  <a:extLst>
                    <a:ext uri="{9D8B030D-6E8A-4147-A177-3AD203B41FA5}">
                      <a16:colId xmlns:a16="http://schemas.microsoft.com/office/drawing/2014/main" val="2460251016"/>
                    </a:ext>
                  </a:extLst>
                </a:gridCol>
              </a:tblGrid>
              <a:tr h="215471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irst half  (RIHR=20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cond half (RIHR=20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0586306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15 patients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16 patients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1459633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Operation time (min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5 (81-164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5 (74-160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251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8623789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nsole time (min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5 (50-132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3 (48-125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04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5354375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hase (min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967882"/>
                  </a:ext>
                </a:extLst>
              </a:tr>
              <a:tr h="215471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eritoneal incision (min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 (20-54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 (18-53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579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4963089"/>
                  </a:ext>
                </a:extLst>
              </a:tr>
              <a:tr h="215471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sh placement (min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 (7-27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 (6-30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162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8990957"/>
                  </a:ext>
                </a:extLst>
              </a:tr>
              <a:tr h="215471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uturing (min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 (3-20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 (4-28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81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430713"/>
                  </a:ext>
                </a:extLst>
              </a:tr>
              <a:tr h="215471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otal time of phase (min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 (41-86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6 (33-82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35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2847826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stimated blood loss (ml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 (0-7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 (0-5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11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9328192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ength of hospital stay (days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 (2-3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 (2-4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447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4554140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mplications (1 week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7421409"/>
                  </a:ext>
                </a:extLst>
              </a:tr>
              <a:tr h="215471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-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6582921"/>
                  </a:ext>
                </a:extLst>
              </a:tr>
              <a:tr h="215471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9476600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mplications (4 weeks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6533521"/>
                  </a:ext>
                </a:extLst>
              </a:tr>
              <a:tr h="350232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rous fluid collection*  (%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 patients (13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 patient (6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512</a:t>
                      </a:r>
                    </a:p>
                  </a:txBody>
                  <a:tcPr marL="8459" marR="8459" marT="845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4258027"/>
                  </a:ext>
                </a:extLst>
              </a:tr>
              <a:tr h="215471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SI**  (%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 patient (6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8913316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nversion (%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-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0118993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eadmission (4 weeks) (%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-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4518703"/>
                  </a:ext>
                </a:extLst>
              </a:tr>
              <a:tr h="215471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ecurrence (4 weeks) (%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-)</a:t>
                      </a:r>
                    </a:p>
                  </a:txBody>
                  <a:tcPr marL="8459" marR="8459" marT="84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8723273"/>
                  </a:ext>
                </a:extLst>
              </a:tr>
            </a:tbl>
          </a:graphicData>
        </a:graphic>
      </p:graphicFrame>
      <p:sp>
        <p:nvSpPr>
          <p:cNvPr id="10" name="Rectangle 1">
            <a:extLst>
              <a:ext uri="{FF2B5EF4-FFF2-40B4-BE49-F238E27FC236}">
                <a16:creationId xmlns:a16="http://schemas.microsoft.com/office/drawing/2014/main" id="{ED76DF13-568D-4A34-B96E-1844E9D165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22838" y="5612528"/>
            <a:ext cx="3538148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xpressed as N (%) or median (range)</a:t>
            </a:r>
            <a:endParaRPr kumimoji="0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, </a:t>
            </a:r>
            <a:r>
              <a:rPr kumimoji="0" lang="en-US" altLang="ja-JP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lavien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indo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grade I, **, </a:t>
            </a:r>
            <a:r>
              <a:rPr kumimoji="0" lang="en-US" altLang="ja-JP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lavien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indo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grade Ⅱ</a:t>
            </a:r>
            <a:endParaRPr kumimoji="0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3723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5</TotalTime>
  <Words>383</Words>
  <Application>Microsoft Office PowerPoint</Application>
  <PresentationFormat>ワイド画面</PresentationFormat>
  <Paragraphs>11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齊藤 卓也</dc:creator>
  <cp:lastModifiedBy>齊藤 卓也</cp:lastModifiedBy>
  <cp:revision>27</cp:revision>
  <cp:lastPrinted>2021-07-09T03:13:50Z</cp:lastPrinted>
  <dcterms:created xsi:type="dcterms:W3CDTF">2021-05-15T09:49:27Z</dcterms:created>
  <dcterms:modified xsi:type="dcterms:W3CDTF">2021-09-01T21:09:36Z</dcterms:modified>
</cp:coreProperties>
</file>